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19" d="100"/>
          <a:sy n="119" d="100"/>
        </p:scale>
        <p:origin x="23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92710AB-F334-CF30-53BF-AAF787437B0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9810A6B-6E10-E403-0CF4-C6146B5B54D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822ED76-C552-46DB-3C17-564A21B8AD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9ACF9-8699-469D-AD38-E53EDF9832E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AE1B842-B175-1112-DCC4-5FF363F0F1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898EB83-0BDC-4FF3-FBBD-D8034CF04F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DE61F-01EA-4E5B-A8C0-C4AC836145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84614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D188034-33E2-D191-5E20-7BF01CD0BD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D450BF7-A776-0CD2-B199-6D5F7C621E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52A366D-0F0B-1BD1-B681-67BF5D6BB9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9ACF9-8699-469D-AD38-E53EDF9832E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F997EFE-C1F6-789E-7232-91946387D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237FE5E-85DB-50D2-ADA0-13A9996E40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DE61F-01EA-4E5B-A8C0-C4AC836145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53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BDD8EEE-0672-A503-4239-A1BD6CB304B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E3E3A15-52AC-FD37-1D0E-CC4F087000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5F4C04E-4E86-E605-EB97-BF5ABD85EF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9ACF9-8699-469D-AD38-E53EDF9832E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4E9E94-2817-B78D-7459-3FAAADA11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A2FC6E0-A06C-FF6A-4FD5-858DF7B2A4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DE61F-01EA-4E5B-A8C0-C4AC836145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61923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BA1011B-4DE6-D0CB-F7D5-144EF1AF51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443F88A-DBFA-C063-79E2-50BAA52FF79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D28A48C-4FA2-2074-C632-0B0F35AB84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9ACF9-8699-469D-AD38-E53EDF9832E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5E10A83-6586-2E8B-C095-71CE9E457B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26CAD42-7F1F-743F-3E87-6F5314D450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DE61F-01EA-4E5B-A8C0-C4AC836145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746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1979A04-12C2-6ADF-872E-29F538A303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B926EA9-5DAE-196F-E3C9-8218538CC2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D8CDC1-8BDC-B3A2-7315-0D0D7A9D84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9ACF9-8699-469D-AD38-E53EDF9832E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008CD3D-F01F-6DEF-A674-F521EEC92A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3726851-CAF3-64BF-A28F-9844F366C4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DE61F-01EA-4E5B-A8C0-C4AC836145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75009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E576E0-FE53-4F14-B4A9-EDF4AE7BBF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6825F8F-E264-DE78-F20A-88CA352C58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4337EEE-09C0-969E-AA42-0E582FBE8F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87F456F-F77C-B695-AC4B-A2979CF26A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9ACF9-8699-469D-AD38-E53EDF9832E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32C8B5B-A099-6B2D-3D5F-10923B229B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2570648-B4F3-91A9-2770-4F6E6B606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DE61F-01EA-4E5B-A8C0-C4AC836145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2964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FCE631E-52DF-7C21-B44A-997829B429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5B27705-9C3B-0455-2A89-9CC0103BC3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5F31C8E-4D3A-893B-71ED-7F92FA3B40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CC14C22-7102-C766-5F67-10FC8B85303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BA0BCB7-6E62-556A-E17C-73A04CA00C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35FABF4-0DB9-8363-3C8A-41D12B49A8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9ACF9-8699-469D-AD38-E53EDF9832E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66FA873-9B55-7815-584B-F9F1AC2710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FAF2460-09B4-047C-FA62-E5856A5B7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DE61F-01EA-4E5B-A8C0-C4AC836145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5003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6DFEAB-F3DA-5214-CBBE-85B6F785C7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59AE445-A165-CB08-7D18-7BFB99B6F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9ACF9-8699-469D-AD38-E53EDF9832E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BF526CF-4743-42C5-652A-72CA99AEA6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A43A844-11E7-A347-6C33-DDD5F22249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DE61F-01EA-4E5B-A8C0-C4AC836145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17226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404FEC4-B67B-81E4-073B-000C7F98D4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9ACF9-8699-469D-AD38-E53EDF9832E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3112763-8787-0862-F57E-7B3B84047F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7E47BD6-35FA-A4E0-C7D0-34DE171ED0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DE61F-01EA-4E5B-A8C0-C4AC836145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68946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DDCC990-A3B4-08A9-3F60-BA7ECA3C98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589C46D-98C5-B326-5435-107EE6BD094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D64E839-B7A0-21AC-94FD-1A935D454B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2795CE3-38C2-BF09-C28C-00ACF9F77A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9ACF9-8699-469D-AD38-E53EDF9832E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640C79C-73FB-2C68-4D70-DF983A3A9F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DC10595-194B-23AE-3357-D1E91CAC1F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DE61F-01EA-4E5B-A8C0-C4AC836145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93549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3372AF-1831-F618-B083-58FF1B1E01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1F9DCB3-2493-E6E5-928D-4703AA533C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E1DE5B1-645F-99E2-536F-A4EE337E86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3C65FB8-05B8-F02B-6F15-DE055A4B92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9ACF9-8699-469D-AD38-E53EDF9832E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FCCA54E-F014-C1A2-7ECD-2E6062D68C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D03EF28-3350-D307-941B-51E515849F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DE61F-01EA-4E5B-A8C0-C4AC836145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93179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E5999BC-5B70-9E5A-B22E-FC576A5A39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DE50131-21FD-22D9-2FDA-2C5790F4CF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F5B7DE3-CFA2-2BC3-6CDE-612910F1769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79ACF9-8699-469D-AD38-E53EDF9832E4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89897B7-175A-275A-F33D-632FAADD6D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A18724C-F154-BC11-5C1B-3D7D1D61510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0DE61F-01EA-4E5B-A8C0-C4AC836145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0482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11" Type="http://schemas.openxmlformats.org/officeDocument/2006/relationships/image" Target="../media/image19.jpe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id="{721C0BBC-331B-26F7-4BEE-F46DE4B3FB93}"/>
              </a:ext>
            </a:extLst>
          </p:cNvPr>
          <p:cNvSpPr/>
          <p:nvPr/>
        </p:nvSpPr>
        <p:spPr>
          <a:xfrm>
            <a:off x="0" y="1672"/>
            <a:ext cx="2175848" cy="414888"/>
          </a:xfrm>
          <a:prstGeom prst="rect">
            <a:avLst/>
          </a:prstGeom>
        </p:spPr>
        <p:style>
          <a:lnRef idx="2">
            <a:schemeClr val="accent5">
              <a:shade val="15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/>
              <a:t>PI3K   85 KDa</a:t>
            </a:r>
            <a:endParaRPr lang="zh-CN" altLang="en-US"/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548DA2C7-8412-2010-A5F7-8DC01E4143DA}"/>
              </a:ext>
            </a:extLst>
          </p:cNvPr>
          <p:cNvSpPr/>
          <p:nvPr/>
        </p:nvSpPr>
        <p:spPr>
          <a:xfrm>
            <a:off x="2499375" y="-11575"/>
            <a:ext cx="2175848" cy="414888"/>
          </a:xfrm>
          <a:prstGeom prst="rect">
            <a:avLst/>
          </a:prstGeom>
        </p:spPr>
        <p:style>
          <a:lnRef idx="2">
            <a:schemeClr val="accent5">
              <a:shade val="15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/>
              <a:t>p-PI3K   85 KDa</a:t>
            </a:r>
            <a:endParaRPr lang="zh-CN" altLang="en-US"/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4C9A7EE8-A3CE-F416-CB4D-F9B6CAB7839B}"/>
              </a:ext>
            </a:extLst>
          </p:cNvPr>
          <p:cNvSpPr/>
          <p:nvPr/>
        </p:nvSpPr>
        <p:spPr>
          <a:xfrm>
            <a:off x="5125656" y="-11575"/>
            <a:ext cx="2175848" cy="414888"/>
          </a:xfrm>
          <a:prstGeom prst="rect">
            <a:avLst/>
          </a:prstGeom>
        </p:spPr>
        <p:style>
          <a:lnRef idx="2">
            <a:schemeClr val="accent5">
              <a:shade val="15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/>
              <a:t>AKT   60 KDa</a:t>
            </a:r>
            <a:endParaRPr lang="zh-CN" altLang="en-US"/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785AED46-CEEE-5BF9-D402-C65108CAE42C}"/>
              </a:ext>
            </a:extLst>
          </p:cNvPr>
          <p:cNvSpPr/>
          <p:nvPr/>
        </p:nvSpPr>
        <p:spPr>
          <a:xfrm>
            <a:off x="7751937" y="-11575"/>
            <a:ext cx="2175848" cy="414888"/>
          </a:xfrm>
          <a:prstGeom prst="rect">
            <a:avLst/>
          </a:prstGeom>
        </p:spPr>
        <p:style>
          <a:lnRef idx="2">
            <a:schemeClr val="accent5">
              <a:shade val="15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/>
              <a:t>p-AKT   60 KDa</a:t>
            </a:r>
            <a:endParaRPr lang="zh-CN" altLang="en-US"/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2A3E231C-E5EF-30DB-B1D5-A2BDE81B2A23}"/>
              </a:ext>
            </a:extLst>
          </p:cNvPr>
          <p:cNvSpPr/>
          <p:nvPr/>
        </p:nvSpPr>
        <p:spPr>
          <a:xfrm>
            <a:off x="10251312" y="1672"/>
            <a:ext cx="1940688" cy="414888"/>
          </a:xfrm>
          <a:prstGeom prst="rect">
            <a:avLst/>
          </a:prstGeom>
        </p:spPr>
        <p:style>
          <a:lnRef idx="2">
            <a:schemeClr val="accent5">
              <a:shade val="15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/>
              <a:t>GAP  37 KDa</a:t>
            </a:r>
            <a:endParaRPr lang="zh-CN" altLang="en-US"/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0AACEE9C-F5BA-C36B-E5D3-5DAEDDCB6C0C}"/>
              </a:ext>
            </a:extLst>
          </p:cNvPr>
          <p:cNvSpPr/>
          <p:nvPr/>
        </p:nvSpPr>
        <p:spPr>
          <a:xfrm>
            <a:off x="0" y="3429000"/>
            <a:ext cx="2175848" cy="414888"/>
          </a:xfrm>
          <a:prstGeom prst="rect">
            <a:avLst/>
          </a:prstGeom>
        </p:spPr>
        <p:style>
          <a:lnRef idx="2">
            <a:schemeClr val="accent5">
              <a:shade val="15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/>
              <a:t>P65  65 KDa</a:t>
            </a:r>
            <a:endParaRPr lang="zh-CN" altLang="en-US"/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29A7ED06-59B6-B559-A93C-21A2A64ECA3A}"/>
              </a:ext>
            </a:extLst>
          </p:cNvPr>
          <p:cNvSpPr/>
          <p:nvPr/>
        </p:nvSpPr>
        <p:spPr>
          <a:xfrm>
            <a:off x="2514807" y="3429000"/>
            <a:ext cx="2175848" cy="414888"/>
          </a:xfrm>
          <a:prstGeom prst="rect">
            <a:avLst/>
          </a:prstGeom>
        </p:spPr>
        <p:style>
          <a:lnRef idx="2">
            <a:schemeClr val="accent5">
              <a:shade val="15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/>
              <a:t>p-P65  65 KDa</a:t>
            </a:r>
            <a:endParaRPr lang="zh-CN" altLang="en-US"/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E9B21918-A99B-27F9-EB48-A56B28BF03F7}"/>
              </a:ext>
            </a:extLst>
          </p:cNvPr>
          <p:cNvSpPr/>
          <p:nvPr/>
        </p:nvSpPr>
        <p:spPr>
          <a:xfrm>
            <a:off x="5133372" y="3417167"/>
            <a:ext cx="2175848" cy="414888"/>
          </a:xfrm>
          <a:prstGeom prst="rect">
            <a:avLst/>
          </a:prstGeom>
        </p:spPr>
        <p:style>
          <a:lnRef idx="2">
            <a:schemeClr val="accent5">
              <a:shade val="15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/>
              <a:t>IKBα  39 KDa</a:t>
            </a:r>
            <a:endParaRPr lang="zh-CN" altLang="en-US"/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24FD35C7-EB33-C99C-ED3E-1C849E7D2241}"/>
              </a:ext>
            </a:extLst>
          </p:cNvPr>
          <p:cNvSpPr/>
          <p:nvPr/>
        </p:nvSpPr>
        <p:spPr>
          <a:xfrm>
            <a:off x="7751937" y="3417167"/>
            <a:ext cx="2175848" cy="414888"/>
          </a:xfrm>
          <a:prstGeom prst="rect">
            <a:avLst/>
          </a:prstGeom>
        </p:spPr>
        <p:style>
          <a:lnRef idx="2">
            <a:schemeClr val="accent5">
              <a:shade val="15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/>
              <a:t>p-IKBα  35 KDa</a:t>
            </a:r>
            <a:endParaRPr lang="zh-CN" altLang="en-US"/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305FB79B-57D0-053D-DE6E-01912E171B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33372" y="413795"/>
            <a:ext cx="2168132" cy="2424211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3A9A7B1B-CF6F-799F-8F59-4D7019B0532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245289" y="413795"/>
            <a:ext cx="1940688" cy="2211482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2CB7D2B0-0D0F-CEC4-DC17-5571F663C60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33372" y="3843886"/>
            <a:ext cx="2175848" cy="2260183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2C00AE1F-74A6-6497-52C2-16332E9E6D3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1" y="3843888"/>
            <a:ext cx="2169827" cy="2307594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CA422E7F-1382-75A0-AD96-201287C138A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745915" y="415596"/>
            <a:ext cx="2175847" cy="2088111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0DE4663F-EBFA-EC93-F11B-28A939B1045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-6021" y="403312"/>
            <a:ext cx="2175847" cy="2462587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D246599B-83AC-3CED-471B-23258CE7084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745915" y="3843886"/>
            <a:ext cx="2181870" cy="2578574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D7632158-536B-5542-2D24-1CE45584E07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508785" y="3843887"/>
            <a:ext cx="2169826" cy="2307593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DF0FE7CB-631C-B51C-FC5B-DDB6CED6B58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493354" y="416560"/>
            <a:ext cx="2175848" cy="22650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25387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组合 25">
            <a:extLst>
              <a:ext uri="{FF2B5EF4-FFF2-40B4-BE49-F238E27FC236}">
                <a16:creationId xmlns:a16="http://schemas.microsoft.com/office/drawing/2014/main" id="{01E9F755-1EFE-D596-E825-75057EFB0823}"/>
              </a:ext>
            </a:extLst>
          </p:cNvPr>
          <p:cNvGrpSpPr/>
          <p:nvPr/>
        </p:nvGrpSpPr>
        <p:grpSpPr>
          <a:xfrm>
            <a:off x="1116498" y="844467"/>
            <a:ext cx="7760802" cy="3544654"/>
            <a:chOff x="1116498" y="844467"/>
            <a:chExt cx="7760802" cy="3544654"/>
          </a:xfrm>
        </p:grpSpPr>
        <p:grpSp>
          <p:nvGrpSpPr>
            <p:cNvPr id="28" name="组合 27">
              <a:extLst>
                <a:ext uri="{FF2B5EF4-FFF2-40B4-BE49-F238E27FC236}">
                  <a16:creationId xmlns:a16="http://schemas.microsoft.com/office/drawing/2014/main" id="{585AA90A-D4F0-E1B3-5B52-8139D4BAEDF5}"/>
                </a:ext>
              </a:extLst>
            </p:cNvPr>
            <p:cNvGrpSpPr/>
            <p:nvPr/>
          </p:nvGrpSpPr>
          <p:grpSpPr>
            <a:xfrm>
              <a:off x="1116498" y="955235"/>
              <a:ext cx="3980532" cy="3366053"/>
              <a:chOff x="1116498" y="955235"/>
              <a:chExt cx="3980532" cy="3366053"/>
            </a:xfrm>
          </p:grpSpPr>
          <p:sp>
            <p:nvSpPr>
              <p:cNvPr id="2" name="文本框 1">
                <a:extLst>
                  <a:ext uri="{FF2B5EF4-FFF2-40B4-BE49-F238E27FC236}">
                    <a16:creationId xmlns:a16="http://schemas.microsoft.com/office/drawing/2014/main" id="{DE81EC08-026B-596E-C480-4CB4A8023518}"/>
                  </a:ext>
                </a:extLst>
              </p:cNvPr>
              <p:cNvSpPr txBox="1"/>
              <p:nvPr/>
            </p:nvSpPr>
            <p:spPr>
              <a:xfrm>
                <a:off x="1355265" y="2653446"/>
                <a:ext cx="688398" cy="2773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3K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" name="文本框 2">
                <a:extLst>
                  <a:ext uri="{FF2B5EF4-FFF2-40B4-BE49-F238E27FC236}">
                    <a16:creationId xmlns:a16="http://schemas.microsoft.com/office/drawing/2014/main" id="{88E232BC-83FF-9280-B7DB-788B51901F33}"/>
                  </a:ext>
                </a:extLst>
              </p:cNvPr>
              <p:cNvSpPr txBox="1"/>
              <p:nvPr/>
            </p:nvSpPr>
            <p:spPr>
              <a:xfrm>
                <a:off x="1360093" y="3381843"/>
                <a:ext cx="645618" cy="2773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KT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" name="文本框 3">
                <a:extLst>
                  <a:ext uri="{FF2B5EF4-FFF2-40B4-BE49-F238E27FC236}">
                    <a16:creationId xmlns:a16="http://schemas.microsoft.com/office/drawing/2014/main" id="{42D56A06-6B63-B2C6-0445-D746D62289DE}"/>
                  </a:ext>
                </a:extLst>
              </p:cNvPr>
              <p:cNvSpPr txBox="1"/>
              <p:nvPr/>
            </p:nvSpPr>
            <p:spPr>
              <a:xfrm>
                <a:off x="1116498" y="3709157"/>
                <a:ext cx="893384" cy="2773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" name="文本框 4">
                <a:extLst>
                  <a:ext uri="{FF2B5EF4-FFF2-40B4-BE49-F238E27FC236}">
                    <a16:creationId xmlns:a16="http://schemas.microsoft.com/office/drawing/2014/main" id="{A04D83B0-9B30-9F75-1F61-A3F6957D63E8}"/>
                  </a:ext>
                </a:extLst>
              </p:cNvPr>
              <p:cNvSpPr txBox="1"/>
              <p:nvPr/>
            </p:nvSpPr>
            <p:spPr>
              <a:xfrm>
                <a:off x="1205205" y="2310784"/>
                <a:ext cx="767886" cy="2773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PI3K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EDAD2719-1846-975A-3B14-4E2CDCE4C054}"/>
                  </a:ext>
                </a:extLst>
              </p:cNvPr>
              <p:cNvSpPr txBox="1"/>
              <p:nvPr/>
            </p:nvSpPr>
            <p:spPr>
              <a:xfrm>
                <a:off x="1205205" y="3000026"/>
                <a:ext cx="774298" cy="2773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AKT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1C54E843-4D11-0138-8593-CE5424D9FBF9}"/>
                  </a:ext>
                </a:extLst>
              </p:cNvPr>
              <p:cNvSpPr txBox="1"/>
              <p:nvPr/>
            </p:nvSpPr>
            <p:spPr>
              <a:xfrm>
                <a:off x="1355265" y="1976333"/>
                <a:ext cx="555316" cy="2773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κBα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2AB57BAF-3EBD-260F-2323-BEE93C588AD6}"/>
                  </a:ext>
                </a:extLst>
              </p:cNvPr>
              <p:cNvSpPr txBox="1"/>
              <p:nvPr/>
            </p:nvSpPr>
            <p:spPr>
              <a:xfrm>
                <a:off x="1216205" y="1633039"/>
                <a:ext cx="695959" cy="2773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IκBα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AC93A5C6-87E9-C519-567A-72A8984FF266}"/>
                  </a:ext>
                </a:extLst>
              </p:cNvPr>
              <p:cNvSpPr txBox="1"/>
              <p:nvPr/>
            </p:nvSpPr>
            <p:spPr>
              <a:xfrm>
                <a:off x="1463895" y="1319597"/>
                <a:ext cx="61709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5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5E5518F2-EBBF-89F3-8245-9B3E7428AAF2}"/>
                  </a:ext>
                </a:extLst>
              </p:cNvPr>
              <p:cNvSpPr txBox="1"/>
              <p:nvPr/>
            </p:nvSpPr>
            <p:spPr>
              <a:xfrm>
                <a:off x="1345001" y="955235"/>
                <a:ext cx="70585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P65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B787F278-6283-0D89-E80B-95DA313B74F5}"/>
                  </a:ext>
                </a:extLst>
              </p:cNvPr>
              <p:cNvSpPr txBox="1"/>
              <p:nvPr/>
            </p:nvSpPr>
            <p:spPr>
              <a:xfrm>
                <a:off x="2072103" y="4013511"/>
                <a:ext cx="190468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G1         G2          G3</a:t>
                </a:r>
                <a:endParaRPr lang="zh-CN" altLang="en-US" sz="14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5" name="图片 14">
                <a:extLst>
                  <a:ext uri="{FF2B5EF4-FFF2-40B4-BE49-F238E27FC236}">
                    <a16:creationId xmlns:a16="http://schemas.microsoft.com/office/drawing/2014/main" id="{204F9C5C-EAAD-5DE0-942C-877E3FBC4D7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949283" y="2695250"/>
                <a:ext cx="2246834" cy="243233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id="{7E536D8B-0B44-EE3E-03BC-32C5B6DF271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945846" y="2329455"/>
                <a:ext cx="2246834" cy="277376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25" name="图片 24">
                <a:extLst>
                  <a:ext uri="{FF2B5EF4-FFF2-40B4-BE49-F238E27FC236}">
                    <a16:creationId xmlns:a16="http://schemas.microsoft.com/office/drawing/2014/main" id="{F7D38A27-F820-0198-7BA9-1B5B2865DC7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945846" y="3725058"/>
                <a:ext cx="2246834" cy="243233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29" name="图片 28">
                <a:extLst>
                  <a:ext uri="{FF2B5EF4-FFF2-40B4-BE49-F238E27FC236}">
                    <a16:creationId xmlns:a16="http://schemas.microsoft.com/office/drawing/2014/main" id="{1B43920F-1640-DC6A-821D-EF807C1CA10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945845" y="3392887"/>
                <a:ext cx="2246834" cy="243234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33" name="图片 32">
                <a:extLst>
                  <a:ext uri="{FF2B5EF4-FFF2-40B4-BE49-F238E27FC236}">
                    <a16:creationId xmlns:a16="http://schemas.microsoft.com/office/drawing/2014/main" id="{7221AC72-E6F9-7807-2B86-FDF9510EA42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945845" y="3030147"/>
                <a:ext cx="2246834" cy="243234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37" name="图片 36">
                <a:extLst>
                  <a:ext uri="{FF2B5EF4-FFF2-40B4-BE49-F238E27FC236}">
                    <a16:creationId xmlns:a16="http://schemas.microsoft.com/office/drawing/2014/main" id="{7AD371D8-D67A-6CCF-6F91-D70375B5CAF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948921" y="1337089"/>
                <a:ext cx="2243759" cy="243233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42" name="图片 41">
                <a:extLst>
                  <a:ext uri="{FF2B5EF4-FFF2-40B4-BE49-F238E27FC236}">
                    <a16:creationId xmlns:a16="http://schemas.microsoft.com/office/drawing/2014/main" id="{EE9667D4-E8B1-CE55-E6BA-D0CB44D0328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945846" y="998323"/>
                <a:ext cx="2246833" cy="243234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45" name="图片 44">
                <a:extLst>
                  <a:ext uri="{FF2B5EF4-FFF2-40B4-BE49-F238E27FC236}">
                    <a16:creationId xmlns:a16="http://schemas.microsoft.com/office/drawing/2014/main" id="{208EC572-A721-A2E0-D6B7-99E150501E7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945846" y="2021969"/>
                <a:ext cx="2246833" cy="243233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47" name="图片 46">
                <a:extLst>
                  <a:ext uri="{FF2B5EF4-FFF2-40B4-BE49-F238E27FC236}">
                    <a16:creationId xmlns:a16="http://schemas.microsoft.com/office/drawing/2014/main" id="{B0897560-5391-C301-5F53-350C3B8E42F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945846" y="1682313"/>
                <a:ext cx="2246833" cy="243233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F995C55E-F86F-BD1D-CE69-773C506F66EA}"/>
                  </a:ext>
                </a:extLst>
              </p:cNvPr>
              <p:cNvSpPr txBox="1"/>
              <p:nvPr/>
            </p:nvSpPr>
            <p:spPr>
              <a:xfrm>
                <a:off x="4206590" y="2659481"/>
                <a:ext cx="76788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5KDa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988BD7F4-5255-D81A-E855-42A1C55420C5}"/>
                  </a:ext>
                </a:extLst>
              </p:cNvPr>
              <p:cNvSpPr txBox="1"/>
              <p:nvPr/>
            </p:nvSpPr>
            <p:spPr>
              <a:xfrm>
                <a:off x="4206928" y="3368373"/>
                <a:ext cx="77429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KDa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BF4D21C4-34FD-15BA-D865-767DD0AAE4D0}"/>
                  </a:ext>
                </a:extLst>
              </p:cNvPr>
              <p:cNvSpPr txBox="1"/>
              <p:nvPr/>
            </p:nvSpPr>
            <p:spPr>
              <a:xfrm>
                <a:off x="4203646" y="3690916"/>
                <a:ext cx="8933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6KDa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CCFF9B33-DBAF-00C7-AADF-24C5D12DD690}"/>
                  </a:ext>
                </a:extLst>
              </p:cNvPr>
              <p:cNvSpPr txBox="1"/>
              <p:nvPr/>
            </p:nvSpPr>
            <p:spPr>
              <a:xfrm>
                <a:off x="4203153" y="2325073"/>
                <a:ext cx="76788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5KDa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A009619B-90EC-746D-BCDF-1CD4503327B5}"/>
                  </a:ext>
                </a:extLst>
              </p:cNvPr>
              <p:cNvSpPr txBox="1"/>
              <p:nvPr/>
            </p:nvSpPr>
            <p:spPr>
              <a:xfrm>
                <a:off x="4206927" y="3013195"/>
                <a:ext cx="77429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KDa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FBA32DFE-A650-C1F9-94D4-820B2B69A6BB}"/>
                  </a:ext>
                </a:extLst>
              </p:cNvPr>
              <p:cNvSpPr txBox="1"/>
              <p:nvPr/>
            </p:nvSpPr>
            <p:spPr>
              <a:xfrm>
                <a:off x="4203552" y="2002769"/>
                <a:ext cx="73332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KDa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19E339C7-12BC-96AC-D9CC-15BF30CE2D39}"/>
                  </a:ext>
                </a:extLst>
              </p:cNvPr>
              <p:cNvSpPr txBox="1"/>
              <p:nvPr/>
            </p:nvSpPr>
            <p:spPr>
              <a:xfrm>
                <a:off x="4203646" y="1653635"/>
                <a:ext cx="78086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9KDa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4F17A10C-4BCA-18B4-6FFF-8BB2C9675AD1}"/>
                  </a:ext>
                </a:extLst>
              </p:cNvPr>
              <p:cNvSpPr txBox="1"/>
              <p:nvPr/>
            </p:nvSpPr>
            <p:spPr>
              <a:xfrm>
                <a:off x="4203646" y="1322240"/>
                <a:ext cx="751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5KDa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7B08B165-9931-046B-489A-BC88DF8297D2}"/>
                  </a:ext>
                </a:extLst>
              </p:cNvPr>
              <p:cNvSpPr txBox="1"/>
              <p:nvPr/>
            </p:nvSpPr>
            <p:spPr>
              <a:xfrm>
                <a:off x="4203646" y="987379"/>
                <a:ext cx="70585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5KDa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2C545C5D-A87C-F478-9779-04A9D0DBD4FA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97286" y="844467"/>
              <a:ext cx="3680014" cy="354465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8987973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03</TotalTime>
  <Words>49</Words>
  <Application>Microsoft Office PowerPoint</Application>
  <PresentationFormat>宽屏</PresentationFormat>
  <Paragraphs>28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X J</dc:creator>
  <cp:lastModifiedBy>clark</cp:lastModifiedBy>
  <cp:revision>13</cp:revision>
  <dcterms:created xsi:type="dcterms:W3CDTF">2025-04-11T07:20:57Z</dcterms:created>
  <dcterms:modified xsi:type="dcterms:W3CDTF">2025-07-27T08:02:23Z</dcterms:modified>
</cp:coreProperties>
</file>